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643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144B63-6A50-FFE3-7445-A64FFC29E6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308BB8-3396-84DD-1A5D-95880342C0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E697C0-59F7-43A0-AA40-E1C6C2440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35DAFC-254B-D68B-0D09-F33FABECA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0796D-9B74-8E16-1A49-29952C540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93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631B85-A6EC-49ED-D90F-D1204ECA55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D7154A-6261-4BD0-6CBC-43F8721909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42F602-1E5F-A2C1-5467-572E79FED1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288967-9FAF-454F-DEDA-D6EE03F778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2A572D-9048-DAC8-D705-390A0E218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442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492706-D5F4-FEA7-4EFC-AE9013A752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23A928-9936-043B-9B2A-D14EE62411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ABE29-A05A-562F-8082-699466E4D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D2B2DC-B115-CCCF-00ED-FB6928B1F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9D4FF9-0FDF-9B22-5D8D-3767165E3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048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E65880-94E8-489F-82AF-9E64A8C712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CEFB1B-60E8-2EED-AE9A-8E06982D69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BB45D3-BEE0-A0E5-5538-F7ABC69A3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9CF2E9-0D1F-2450-DD81-5B688DFC41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1BBB0A-52DC-608F-50FF-2890B7AC4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841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5B76BA-150D-1F20-D35C-EA35E727E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D632A6-8D0A-3D74-3057-504CF943F1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960B4D-A2C7-1478-312E-7C32D471E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B40834-8915-0D39-B454-8614F1F65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B56F1C-1FA2-23BF-CB59-B0EADE6DC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336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F2CA6E-CE3D-900E-28AA-1500C00768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21FDAF-648E-F051-741C-2368A99A50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231302-D47F-C968-34E2-3C1BB61845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0D8615-0436-9293-1224-2102D83206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6D6346-A1F9-5DBC-F299-4195BD67F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89EC82-835E-B515-6A27-478B9877C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515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7FB1A6-B210-E091-EC09-4A0F5A2FEA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C3D554-DE3B-7CEB-43E0-8944C82EFE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0C7B37-C707-E843-67AD-99F6870DAA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1CC427-9EC5-F4D8-3357-5067CC8FCB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219444A-9F55-87C2-07E1-2936845FCA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C7FA50-A0D8-F871-DC4C-986F9DB183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9FFAF0-45BB-806B-B963-974A008D5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CBB8946-1E05-27F1-95F2-4A7934EE0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865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CAC633-F352-3A72-2ADA-03F80BFE5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05C105-1813-1CCE-6A4C-9B26A4079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DBB0AC-4CDA-4361-FDF3-C3A9AB18C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B2E810-B804-9A0F-E4CF-8B4EF7B84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168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F8B76D-235F-B25C-96D0-7940AFBD0E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938182-6C87-55C5-A93F-8F360579C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223745-9DB8-679E-D12C-9D365A006F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503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CB731-E0EC-F9F4-417C-11524E6FCD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866468-3D8E-05E9-90AE-7406864E97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804F44-758B-7AF3-8CBC-D15A7D66AE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E43541-4299-812E-3196-D6E08DF2E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2F6E94-4DA8-E822-6600-14EE7F636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EEEA20-2BFA-360B-485E-E1403D0B7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714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AC9785-3FBC-5E68-0EF0-83F9CEAE2F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9B5654A-FC52-59C3-F326-62AB04D529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F7876E-22D8-6B60-4B49-6FCA1E5BEC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387D9F-B6FC-D534-831B-024F61164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A43E60-8EC5-93B1-BFB4-4196C6F05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38A710-A473-D8A3-9B54-CBA848379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166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17693D-65A5-D25C-0B7F-8E91701ADD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991075-1B3F-6128-7732-5ADCDCAC12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9452B9-46BD-55FA-C57C-7228BC09659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5C7636-B183-4DEC-A9A4-1C396674A1D2}" type="datetimeFigureOut">
              <a:rPr lang="en-US" smtClean="0"/>
              <a:t>11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480047-BDFC-0AA0-051E-27577985AB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8198D5-6C1C-C1AF-CC29-8FA1CCC7DC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01EB96-97F5-44C4-8D1A-D33B272DD2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3321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DB2634B-6765-EE1A-2B3C-BD54CDED26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F65493E-882B-152B-06A6-0416C02E2D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35442" y="526699"/>
            <a:ext cx="4080074" cy="304807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160B197-33D3-CC6D-7C81-D1D80065ED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35442" y="3722653"/>
            <a:ext cx="4080074" cy="304838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92A4675-F2AA-580C-6C78-DE4C815CEBA0}"/>
              </a:ext>
            </a:extLst>
          </p:cNvPr>
          <p:cNvSpPr txBox="1"/>
          <p:nvPr/>
        </p:nvSpPr>
        <p:spPr>
          <a:xfrm>
            <a:off x="5993727" y="4982577"/>
            <a:ext cx="365385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dder: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cision Plus Protein™ Unstained Protein Standards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Ra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#1610363)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D5FE88-B481-8E10-B704-A07E7492C77A}"/>
              </a:ext>
            </a:extLst>
          </p:cNvPr>
          <p:cNvSpPr txBox="1"/>
          <p:nvPr/>
        </p:nvSpPr>
        <p:spPr>
          <a:xfrm>
            <a:off x="1391477" y="60458"/>
            <a:ext cx="27299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1C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D51466C-DE06-3897-003F-3A29EDB6DE9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8494889"/>
              </p:ext>
            </p:extLst>
          </p:nvPr>
        </p:nvGraphicFramePr>
        <p:xfrm>
          <a:off x="5825331" y="337457"/>
          <a:ext cx="3990645" cy="43513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8129">
                  <a:extLst>
                    <a:ext uri="{9D8B030D-6E8A-4147-A177-3AD203B41FA5}">
                      <a16:colId xmlns:a16="http://schemas.microsoft.com/office/drawing/2014/main" val="2428415406"/>
                    </a:ext>
                  </a:extLst>
                </a:gridCol>
                <a:gridCol w="798129">
                  <a:extLst>
                    <a:ext uri="{9D8B030D-6E8A-4147-A177-3AD203B41FA5}">
                      <a16:colId xmlns:a16="http://schemas.microsoft.com/office/drawing/2014/main" val="172936085"/>
                    </a:ext>
                  </a:extLst>
                </a:gridCol>
                <a:gridCol w="798129">
                  <a:extLst>
                    <a:ext uri="{9D8B030D-6E8A-4147-A177-3AD203B41FA5}">
                      <a16:colId xmlns:a16="http://schemas.microsoft.com/office/drawing/2014/main" val="1295633987"/>
                    </a:ext>
                  </a:extLst>
                </a:gridCol>
                <a:gridCol w="798129">
                  <a:extLst>
                    <a:ext uri="{9D8B030D-6E8A-4147-A177-3AD203B41FA5}">
                      <a16:colId xmlns:a16="http://schemas.microsoft.com/office/drawing/2014/main" val="2623685219"/>
                    </a:ext>
                  </a:extLst>
                </a:gridCol>
                <a:gridCol w="798129">
                  <a:extLst>
                    <a:ext uri="{9D8B030D-6E8A-4147-A177-3AD203B41FA5}">
                      <a16:colId xmlns:a16="http://schemas.microsoft.com/office/drawing/2014/main" val="1154554367"/>
                    </a:ext>
                  </a:extLst>
                </a:gridCol>
              </a:tblGrid>
              <a:tr h="1611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l lan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in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 or Nx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extLst>
                  <a:ext uri="{0D108BD9-81ED-4DB2-BD59-A6C34878D82A}">
                    <a16:rowId xmlns:a16="http://schemas.microsoft.com/office/drawing/2014/main" val="49108822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dd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81263461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44467721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18724997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50077450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24517765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49475128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8945851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15421485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20853696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69344465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84683912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94584321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81068316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48430373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21212015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57940387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7276240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95358857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80109052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77201135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58470094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08697393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60260003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089696010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50497246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dd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3240586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396466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white background&#10;&#10;AI-generated content may be incorrect.">
            <a:extLst>
              <a:ext uri="{FF2B5EF4-FFF2-40B4-BE49-F238E27FC236}">
                <a16:creationId xmlns:a16="http://schemas.microsoft.com/office/drawing/2014/main" id="{3D2E9198-6A77-548C-EC3D-19746168F6A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5442" y="526699"/>
            <a:ext cx="4080074" cy="3048075"/>
          </a:xfrm>
          <a:prstGeom prst="rect">
            <a:avLst/>
          </a:prstGeom>
        </p:spPr>
      </p:pic>
      <p:pic>
        <p:nvPicPr>
          <p:cNvPr id="7" name="Picture 6" descr="A close-up of a white rectangular object&#10;&#10;AI-generated content may be incorrect.">
            <a:extLst>
              <a:ext uri="{FF2B5EF4-FFF2-40B4-BE49-F238E27FC236}">
                <a16:creationId xmlns:a16="http://schemas.microsoft.com/office/drawing/2014/main" id="{40B0DE5D-8FA5-D6E5-2DB4-D6606EB77E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5442" y="3722653"/>
            <a:ext cx="4080074" cy="3048385"/>
          </a:xfrm>
          <a:prstGeom prst="rect">
            <a:avLst/>
          </a:prstGeom>
        </p:spPr>
      </p:pic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39E81481-8B04-E80C-159B-F8643734E4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1254476"/>
              </p:ext>
            </p:extLst>
          </p:nvPr>
        </p:nvGraphicFramePr>
        <p:xfrm>
          <a:off x="5832960" y="631230"/>
          <a:ext cx="3990645" cy="435134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8129">
                  <a:extLst>
                    <a:ext uri="{9D8B030D-6E8A-4147-A177-3AD203B41FA5}">
                      <a16:colId xmlns:a16="http://schemas.microsoft.com/office/drawing/2014/main" val="4014257121"/>
                    </a:ext>
                  </a:extLst>
                </a:gridCol>
                <a:gridCol w="798129">
                  <a:extLst>
                    <a:ext uri="{9D8B030D-6E8A-4147-A177-3AD203B41FA5}">
                      <a16:colId xmlns:a16="http://schemas.microsoft.com/office/drawing/2014/main" val="2662672686"/>
                    </a:ext>
                  </a:extLst>
                </a:gridCol>
                <a:gridCol w="798129">
                  <a:extLst>
                    <a:ext uri="{9D8B030D-6E8A-4147-A177-3AD203B41FA5}">
                      <a16:colId xmlns:a16="http://schemas.microsoft.com/office/drawing/2014/main" val="1713781"/>
                    </a:ext>
                  </a:extLst>
                </a:gridCol>
                <a:gridCol w="798129">
                  <a:extLst>
                    <a:ext uri="{9D8B030D-6E8A-4147-A177-3AD203B41FA5}">
                      <a16:colId xmlns:a16="http://schemas.microsoft.com/office/drawing/2014/main" val="804858829"/>
                    </a:ext>
                  </a:extLst>
                </a:gridCol>
                <a:gridCol w="798129">
                  <a:extLst>
                    <a:ext uri="{9D8B030D-6E8A-4147-A177-3AD203B41FA5}">
                      <a16:colId xmlns:a16="http://schemas.microsoft.com/office/drawing/2014/main" val="295576043"/>
                    </a:ext>
                  </a:extLst>
                </a:gridCol>
              </a:tblGrid>
              <a:tr h="161161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l lan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in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 or Nx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ctr"/>
                </a:tc>
                <a:extLst>
                  <a:ext uri="{0D108BD9-81ED-4DB2-BD59-A6C34878D82A}">
                    <a16:rowId xmlns:a16="http://schemas.microsoft.com/office/drawing/2014/main" val="268877659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dde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46527198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33249667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99078001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04860576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11624897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89308327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59667325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74275065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190246539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5407296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27170929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65685436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302177074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90177267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60546575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90742230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921008615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131981341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72019150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84968010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154143512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681226426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155026927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2579277298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4004829183"/>
                  </a:ext>
                </a:extLst>
              </a:tr>
              <a:tr h="161161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dd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139" marR="6139" marT="6139" marB="0" anchor="b"/>
                </a:tc>
                <a:extLst>
                  <a:ext uri="{0D108BD9-81ED-4DB2-BD59-A6C34878D82A}">
                    <a16:rowId xmlns:a16="http://schemas.microsoft.com/office/drawing/2014/main" val="3120658117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074BEA52-B9B0-BF16-4A05-7CC18E907491}"/>
              </a:ext>
            </a:extLst>
          </p:cNvPr>
          <p:cNvSpPr txBox="1"/>
          <p:nvPr/>
        </p:nvSpPr>
        <p:spPr>
          <a:xfrm>
            <a:off x="5993727" y="4982577"/>
            <a:ext cx="365385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dder: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cision Plus Protein™ Unstained Protein Standards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Ra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#1610363)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EC6BB1E-6894-DE89-DB66-043C6C574E12}"/>
              </a:ext>
            </a:extLst>
          </p:cNvPr>
          <p:cNvSpPr txBox="1"/>
          <p:nvPr/>
        </p:nvSpPr>
        <p:spPr>
          <a:xfrm>
            <a:off x="1391477" y="60458"/>
            <a:ext cx="27299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1D</a:t>
            </a:r>
          </a:p>
        </p:txBody>
      </p:sp>
    </p:spTree>
    <p:extLst>
      <p:ext uri="{BB962C8B-B14F-4D97-AF65-F5344CB8AC3E}">
        <p14:creationId xmlns:p14="http://schemas.microsoft.com/office/powerpoint/2010/main" val="36852804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DF7C497-4AFA-299A-7B95-69467E92887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AA5F117-9B70-7407-7750-7447D157136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35442" y="526699"/>
            <a:ext cx="4080074" cy="304807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340C6DB-4604-2435-03FE-B80E9FC4F0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335442" y="3722891"/>
            <a:ext cx="4080074" cy="304790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93038EE-47D5-CE1D-AA58-6332FA710800}"/>
              </a:ext>
            </a:extLst>
          </p:cNvPr>
          <p:cNvSpPr txBox="1"/>
          <p:nvPr/>
        </p:nvSpPr>
        <p:spPr>
          <a:xfrm>
            <a:off x="5993727" y="4982577"/>
            <a:ext cx="365385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dder: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cision Plus Protein™ Unstained Protein Standards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Ra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#1610363)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2200746-5982-226B-6BD9-85D4FFF0475D}"/>
              </a:ext>
            </a:extLst>
          </p:cNvPr>
          <p:cNvSpPr txBox="1"/>
          <p:nvPr/>
        </p:nvSpPr>
        <p:spPr>
          <a:xfrm>
            <a:off x="1391477" y="60458"/>
            <a:ext cx="27299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ource data for figure 1C and 1D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5D9CD9E-2EB8-260C-F5E1-92BEDDB84E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4470516"/>
              </p:ext>
            </p:extLst>
          </p:nvPr>
        </p:nvGraphicFramePr>
        <p:xfrm>
          <a:off x="5786230" y="526699"/>
          <a:ext cx="4953000" cy="38004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90600">
                  <a:extLst>
                    <a:ext uri="{9D8B030D-6E8A-4147-A177-3AD203B41FA5}">
                      <a16:colId xmlns:a16="http://schemas.microsoft.com/office/drawing/2014/main" val="1011883030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3051312415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3603023920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1920962796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796204503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l lane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ain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 or Nx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5452337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dd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65378274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57175661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9003333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98261724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23897124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77510446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32687982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25954937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79554096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12903786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92284325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14872225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69864896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755471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6/1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82011772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KO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33171242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v 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44947041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dder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12008131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94473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474</Words>
  <Application>Microsoft Office PowerPoint</Application>
  <PresentationFormat>Widescreen</PresentationFormat>
  <Paragraphs>37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easure, Joe</dc:creator>
  <cp:lastModifiedBy>Joseph Leasure</cp:lastModifiedBy>
  <cp:revision>1</cp:revision>
  <dcterms:created xsi:type="dcterms:W3CDTF">2025-03-07T15:44:13Z</dcterms:created>
  <dcterms:modified xsi:type="dcterms:W3CDTF">2025-11-10T22:00:17Z</dcterms:modified>
</cp:coreProperties>
</file>